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040313" cy="82804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A4C07E8-EEAA-40D1-B95A-329F1D8825D2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52360" y="1936800"/>
            <a:ext cx="453384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52360" y="4790160"/>
            <a:ext cx="453384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C4159E3-EFC5-4BFD-A0D7-AC0E2B0F0E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52360" y="193680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575440" y="193680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52360" y="479016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575440" y="479016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307B2B9-B95D-4B20-9BFB-22C732EF7C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52360" y="1936800"/>
            <a:ext cx="14598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785600" y="1936800"/>
            <a:ext cx="14598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318840" y="1936800"/>
            <a:ext cx="14598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52360" y="4790160"/>
            <a:ext cx="14598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785600" y="4790160"/>
            <a:ext cx="14598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318840" y="4790160"/>
            <a:ext cx="14598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CB08D55-80B4-414F-A52F-57AB6541B4F8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52360" y="1936800"/>
            <a:ext cx="453384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E796139-3F01-4715-AC81-0A5D449675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52360" y="1936800"/>
            <a:ext cx="453384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319E1F1-573B-4B00-89E9-7CE45A960E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52360" y="1936800"/>
            <a:ext cx="221220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575440" y="1936800"/>
            <a:ext cx="221220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14F42C2-677B-4113-8F52-C8ACFC06D9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384B0C0-657A-4277-A1F8-2B1334D82E9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77640" y="2571480"/>
            <a:ext cx="4282920" cy="821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6700263-4579-448D-88C3-4642D049296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52360" y="193680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575440" y="1936800"/>
            <a:ext cx="221220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52360" y="479016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3FFE40D-D067-4B09-A9D7-5502B9E13A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52360" y="1936800"/>
            <a:ext cx="221220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575440" y="193680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575440" y="479016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6F71639-BD45-47F9-B94D-32053DBC9D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52360" y="193680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575440" y="193680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52360" y="4790160"/>
            <a:ext cx="453384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5071329-1023-4993-93E0-F891BFF0F1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dt" idx="1"/>
          </p:nvPr>
        </p:nvSpPr>
        <p:spPr>
          <a:xfrm>
            <a:off x="252000" y="7675560"/>
            <a:ext cx="1174680" cy="43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  <a:defRPr b="0" lang="en-PH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0" lang="en-PH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7/28/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1722600" y="7675560"/>
            <a:ext cx="1595160" cy="44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sldNum" idx="2"/>
          </p:nvPr>
        </p:nvSpPr>
        <p:spPr>
          <a:xfrm>
            <a:off x="3611160" y="7675560"/>
            <a:ext cx="1174680" cy="43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  <a:defRPr b="0" lang="en-PH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fld id="{30C0132D-8F17-4A4B-8AB0-D7B27F2D40CA}" type="slidenum">
              <a:rPr b="0" lang="en-PH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252360" y="1936800"/>
            <a:ext cx="453384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7000"/>
          </a:bodyPr>
          <a:p>
            <a:pPr marL="29844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298440" indent="-2984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298440" indent="-2984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298440" indent="-2984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98440" indent="-2984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98440" indent="-2984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98440" indent="-2984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081080" y="468360"/>
            <a:ext cx="2698560" cy="2698200"/>
            <a:chOff x="1081080" y="468360"/>
            <a:chExt cx="2698560" cy="269820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1081080" y="468360"/>
              <a:ext cx="1321560" cy="1321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" descr=""/>
            <p:cNvPicPr/>
            <p:nvPr/>
          </p:nvPicPr>
          <p:blipFill>
            <a:blip r:embed="rId2"/>
            <a:stretch/>
          </p:blipFill>
          <p:spPr>
            <a:xfrm>
              <a:off x="1081080" y="1845360"/>
              <a:ext cx="1321560" cy="1321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" descr=""/>
            <p:cNvPicPr/>
            <p:nvPr/>
          </p:nvPicPr>
          <p:blipFill>
            <a:blip r:embed="rId3"/>
            <a:stretch/>
          </p:blipFill>
          <p:spPr>
            <a:xfrm>
              <a:off x="2458080" y="468360"/>
              <a:ext cx="1321560" cy="1321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4"/>
            <a:stretch/>
          </p:blipFill>
          <p:spPr>
            <a:xfrm>
              <a:off x="2458080" y="1845360"/>
              <a:ext cx="1321560" cy="13212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46" name=""/>
          <p:cNvGrpSpPr/>
          <p:nvPr/>
        </p:nvGrpSpPr>
        <p:grpSpPr>
          <a:xfrm>
            <a:off x="1081080" y="3924360"/>
            <a:ext cx="2698560" cy="2698200"/>
            <a:chOff x="1081080" y="3924360"/>
            <a:chExt cx="2698560" cy="2698200"/>
          </a:xfrm>
        </p:grpSpPr>
        <p:pic>
          <p:nvPicPr>
            <p:cNvPr id="47" name="" descr=""/>
            <p:cNvPicPr/>
            <p:nvPr/>
          </p:nvPicPr>
          <p:blipFill>
            <a:blip r:embed="rId5"/>
            <a:stretch/>
          </p:blipFill>
          <p:spPr>
            <a:xfrm>
              <a:off x="1081080" y="3924360"/>
              <a:ext cx="1321560" cy="1321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" descr=""/>
            <p:cNvPicPr/>
            <p:nvPr/>
          </p:nvPicPr>
          <p:blipFill>
            <a:blip r:embed="rId6"/>
            <a:stretch/>
          </p:blipFill>
          <p:spPr>
            <a:xfrm>
              <a:off x="1081080" y="5301360"/>
              <a:ext cx="1321560" cy="1321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" descr=""/>
            <p:cNvPicPr/>
            <p:nvPr/>
          </p:nvPicPr>
          <p:blipFill>
            <a:blip r:embed="rId7"/>
            <a:stretch/>
          </p:blipFill>
          <p:spPr>
            <a:xfrm>
              <a:off x="2458080" y="3924360"/>
              <a:ext cx="1321560" cy="1321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" descr=""/>
            <p:cNvPicPr/>
            <p:nvPr/>
          </p:nvPicPr>
          <p:blipFill>
            <a:blip r:embed="rId8"/>
            <a:stretch/>
          </p:blipFill>
          <p:spPr>
            <a:xfrm>
              <a:off x="2458080" y="5301360"/>
              <a:ext cx="1321560" cy="13212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1" name=""/>
          <p:cNvSpPr/>
          <p:nvPr/>
        </p:nvSpPr>
        <p:spPr>
          <a:xfrm>
            <a:off x="1440" y="0"/>
            <a:ext cx="31932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PH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8280" y="3564000"/>
            <a:ext cx="30888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PH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811960" y="179280"/>
            <a:ext cx="53748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PH" sz="1200" spc="-1" strike="noStrike">
                <a:solidFill>
                  <a:srgbClr val="000000"/>
                </a:solidFill>
                <a:latin typeface="Calibri"/>
              </a:rPr>
              <a:t>+ RI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514520" y="179280"/>
            <a:ext cx="50832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PH" sz="1200" spc="-1" strike="noStrike">
                <a:solidFill>
                  <a:srgbClr val="000000"/>
                </a:solidFill>
                <a:latin typeface="Calibri"/>
              </a:rPr>
              <a:t>- RI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rot="16200000">
            <a:off x="747720" y="928800"/>
            <a:ext cx="38340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PH" sz="1200" spc="-1" strike="noStrike">
                <a:solidFill>
                  <a:srgbClr val="000000"/>
                </a:solidFill>
                <a:latin typeface="Calibri"/>
              </a:rPr>
              <a:t>- I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rot="16200000">
            <a:off x="418680" y="2307600"/>
            <a:ext cx="104184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0" lang="en-PH" sz="1200" spc="-1" strike="noStrike">
                <a:solidFill>
                  <a:srgbClr val="000000"/>
                </a:solidFill>
                <a:latin typeface="Calibri"/>
              </a:rPr>
              <a:t>16Gy 180 m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914920" y="3657600"/>
            <a:ext cx="53748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PH" sz="1200" spc="-1" strike="noStrike">
                <a:solidFill>
                  <a:srgbClr val="000000"/>
                </a:solidFill>
                <a:latin typeface="Calibri"/>
              </a:rPr>
              <a:t>+ RI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546200" y="3657600"/>
            <a:ext cx="50832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PH" sz="1200" spc="-1" strike="noStrike">
                <a:solidFill>
                  <a:srgbClr val="000000"/>
                </a:solidFill>
                <a:latin typeface="Calibri"/>
              </a:rPr>
              <a:t>- RI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rot="16200000">
            <a:off x="779760" y="4406400"/>
            <a:ext cx="38340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PH" sz="1200" spc="-1" strike="noStrike">
                <a:solidFill>
                  <a:srgbClr val="000000"/>
                </a:solidFill>
                <a:latin typeface="Calibri"/>
              </a:rPr>
              <a:t>- I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rot="16200000">
            <a:off x="450720" y="5784120"/>
            <a:ext cx="104184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0" lang="en-PH" sz="1200" spc="-1" strike="noStrike">
                <a:solidFill>
                  <a:srgbClr val="000000"/>
                </a:solidFill>
                <a:latin typeface="Calibri"/>
              </a:rPr>
              <a:t>16Gy 180 m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803240" y="3203640"/>
            <a:ext cx="123696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0" lang="en-PH" sz="1200" spc="-1" strike="noStrike">
                <a:solidFill>
                  <a:srgbClr val="000000"/>
                </a:solidFill>
                <a:latin typeface="Calibri"/>
              </a:rPr>
              <a:t>GSC-11 (group 1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927080" y="6661080"/>
            <a:ext cx="123696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0" lang="en-PH" sz="1200" spc="-1" strike="noStrike">
                <a:solidFill>
                  <a:srgbClr val="000000"/>
                </a:solidFill>
                <a:latin typeface="Calibri"/>
              </a:rPr>
              <a:t>GSC-14 (group 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0" y="7077240"/>
            <a:ext cx="5040360" cy="100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PH" sz="1200" spc="-1" strike="noStrike">
                <a:solidFill>
                  <a:srgbClr val="000000"/>
                </a:solidFill>
                <a:latin typeface="Calibri"/>
                <a:ea typeface="Calibri"/>
              </a:rPr>
              <a:t>Figure S2: Representative comet images of A) GSC-11 </a:t>
            </a:r>
            <a:br>
              <a:rPr sz="1200"/>
            </a:br>
            <a:r>
              <a:rPr b="1" lang="en-PH" sz="1200" spc="-1" strike="noStrike">
                <a:solidFill>
                  <a:srgbClr val="000000"/>
                </a:solidFill>
                <a:latin typeface="Calibri"/>
                <a:ea typeface="Calibri"/>
              </a:rPr>
              <a:t>(group 1) and B) GSC-14 (group 2) after RI-1 treatment and 16Gy IR (t=180 mi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PH" sz="1200" spc="-1" strike="noStrike">
                <a:solidFill>
                  <a:srgbClr val="000000"/>
                </a:solidFill>
                <a:latin typeface="Calibri"/>
                <a:ea typeface="Calibri"/>
              </a:rPr>
              <a:t>Comet images were captured with the Axio Imager M2 fluorescent microscope (Carl Zeiss) at 20x (scale bar 100µm). IR, Ionizing radi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